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</p:sldIdLst>
  <p:sldSz cx="6858000" cy="9144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879" autoAdjust="0"/>
    <p:restoredTop sz="94660"/>
  </p:normalViewPr>
  <p:slideViewPr>
    <p:cSldViewPr snapToGrid="0">
      <p:cViewPr>
        <p:scale>
          <a:sx n="125" d="100"/>
          <a:sy n="125" d="100"/>
        </p:scale>
        <p:origin x="-2634" y="6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4475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2028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2839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758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2558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053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8632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9100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5389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6779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871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7859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テキスト ボックス 10"/>
          <p:cNvSpPr txBox="1"/>
          <p:nvPr/>
        </p:nvSpPr>
        <p:spPr>
          <a:xfrm rot="16200000">
            <a:off x="865003" y="3318361"/>
            <a:ext cx="1303562" cy="5283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700"/>
              </a:lnSpc>
            </a:pPr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ght intensity</a:t>
            </a:r>
          </a:p>
          <a:p>
            <a:pPr algn="ctr">
              <a:lnSpc>
                <a:spcPts val="1700"/>
              </a:lnSpc>
            </a:pPr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10</a:t>
            </a:r>
            <a:r>
              <a:rPr lang="en-US" altLang="ja-JP" sz="1200" b="1" baseline="300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4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 </a:t>
            </a:r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s/s)</a:t>
            </a: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83333" y="5327280"/>
            <a:ext cx="569133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5: Fig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.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termediate precision of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uminescence measurements during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al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eriod. Before measurement of luminescence from 3D spheroids at each measurement point, light intensity was measured with a standard LED plate for 5 s at 37˚C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362" y="2565466"/>
            <a:ext cx="3114675" cy="2457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170743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02</TotalTime>
  <Words>53</Words>
  <Application>Microsoft Office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jima</dc:creator>
  <cp:lastModifiedBy>nakajima</cp:lastModifiedBy>
  <cp:revision>232</cp:revision>
  <cp:lastPrinted>2017-03-26T11:04:21Z</cp:lastPrinted>
  <dcterms:created xsi:type="dcterms:W3CDTF">2014-01-04T11:44:56Z</dcterms:created>
  <dcterms:modified xsi:type="dcterms:W3CDTF">2017-06-14T11:56:20Z</dcterms:modified>
</cp:coreProperties>
</file>